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299" r:id="rId2"/>
  </p:sldIdLst>
  <p:sldSz cx="9144000" cy="6858000" type="screen4x3"/>
  <p:notesSz cx="6858000" cy="9144000"/>
  <p:defaultTextStyle>
    <a:defPPr>
      <a:defRPr lang="zh-TW"/>
    </a:defPPr>
    <a:lvl1pPr marL="0" algn="l" defTabSz="91427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1pPr>
    <a:lvl2pPr marL="457139" algn="l" defTabSz="91427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2pPr>
    <a:lvl3pPr marL="914277" algn="l" defTabSz="91427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3pPr>
    <a:lvl4pPr marL="1371417" algn="l" defTabSz="91427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4pPr>
    <a:lvl5pPr marL="1828556" algn="l" defTabSz="91427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5pPr>
    <a:lvl6pPr marL="2285695" algn="l" defTabSz="91427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6pPr>
    <a:lvl7pPr marL="2742833" algn="l" defTabSz="91427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7pPr>
    <a:lvl8pPr marL="3199972" algn="l" defTabSz="91427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8pPr>
    <a:lvl9pPr marL="3657112" algn="l" defTabSz="91427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548" autoAdjust="0"/>
  </p:normalViewPr>
  <p:slideViewPr>
    <p:cSldViewPr snapToGrid="0">
      <p:cViewPr varScale="1">
        <p:scale>
          <a:sx n="160" d="100"/>
          <a:sy n="160" d="100"/>
        </p:scale>
        <p:origin x="-152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29DF7F-5E72-4F1E-A2F5-75A8E237D325}" type="datetimeFigureOut">
              <a:rPr lang="zh-TW" altLang="en-US" smtClean="0"/>
              <a:t>19/8/13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4ACEAE-69E0-41B4-898F-4D22E61B338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61879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7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39" algn="l" defTabSz="91427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77" algn="l" defTabSz="91427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417" algn="l" defTabSz="91427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56" algn="l" defTabSz="91427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95" algn="l" defTabSz="91427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833" algn="l" defTabSz="91427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972" algn="l" defTabSz="91427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112" algn="l" defTabSz="91427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4ACEAE-69E0-41B4-898F-4D22E61B3388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473097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1.png"/><Relationship Id="rId3" Type="http://schemas.microsoft.com/office/2007/relationships/hdphoto" Target="../media/hdphoto1.wdp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CD2E83A-6751-49E4-9E83-E42E570D1195}" type="datetime1">
              <a:rPr lang="zh-TW" altLang="en-US" sz="901" smtClean="0">
                <a:solidFill>
                  <a:srgbClr val="0F6FC6">
                    <a:lumMod val="75000"/>
                    <a:lumOff val="25000"/>
                  </a:srgbClr>
                </a:solidFill>
                <a:latin typeface="Times New Roman"/>
                <a:ea typeface="標楷體"/>
              </a:rPr>
              <a:pPr>
                <a:defRPr/>
              </a:pPr>
              <a:t>19/8/13</a:t>
            </a:fld>
            <a:endParaRPr lang="zh-TW" altLang="en-US" sz="901">
              <a:solidFill>
                <a:srgbClr val="0F6FC6">
                  <a:lumMod val="75000"/>
                  <a:lumOff val="25000"/>
                </a:srgbClr>
              </a:solidFill>
              <a:latin typeface="Times New Roman"/>
              <a:ea typeface="標楷體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TW" altLang="en-US" sz="901">
              <a:solidFill>
                <a:srgbClr val="0F6FC6">
                  <a:lumMod val="75000"/>
                  <a:lumOff val="25000"/>
                </a:srgbClr>
              </a:solidFill>
              <a:latin typeface="Times New Roman"/>
              <a:ea typeface="標楷體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066A31-7E54-4457-B739-5849F72B97A7}" type="slidenum">
              <a:rPr lang="zh-TW" altLang="en-US" sz="1500" smtClean="0">
                <a:solidFill>
                  <a:srgbClr val="0F6FC6">
                    <a:lumMod val="75000"/>
                    <a:lumOff val="25000"/>
                  </a:srgbClr>
                </a:solidFill>
                <a:latin typeface="標楷體" panose="03000509000000000000" pitchFamily="65" charset="-120"/>
                <a:ea typeface="標楷體" panose="03000509000000000000" pitchFamily="65" charset="-120"/>
              </a:rPr>
              <a:pPr>
                <a:defRPr/>
              </a:pPr>
              <a:t>‹#›</a:t>
            </a:fld>
            <a:endParaRPr lang="zh-TW" altLang="en-US" sz="1500">
              <a:solidFill>
                <a:srgbClr val="0F6FC6">
                  <a:lumMod val="75000"/>
                  <a:lumOff val="25000"/>
                </a:srgbClr>
              </a:solidFill>
              <a:latin typeface="標楷體" panose="03000509000000000000" pitchFamily="65" charset="-120"/>
              <a:ea typeface="標楷體" panose="03000509000000000000" pitchFamily="65" charset="-120"/>
            </a:endParaRPr>
          </a:p>
        </p:txBody>
      </p:sp>
      <p:pic>
        <p:nvPicPr>
          <p:cNvPr id="7" name="Picture 3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0" b="100000" l="0" r="100000">
                        <a14:foregroundMark x1="31347" y1="32440" x2="31347" y2="32440"/>
                        <a14:foregroundMark x1="22958" y1="27381" x2="22958" y2="27381"/>
                        <a14:foregroundMark x1="11700" y1="25893" x2="11700" y2="25893"/>
                        <a14:foregroundMark x1="19205" y1="15774" x2="19205" y2="15774"/>
                        <a14:foregroundMark x1="30022" y1="14583" x2="30022" y2="14583"/>
                        <a14:foregroundMark x1="40839" y1="20833" x2="40839" y2="20833"/>
                        <a14:foregroundMark x1="58720" y1="41369" x2="58720" y2="41369"/>
                        <a14:foregroundMark x1="72848" y1="45238" x2="72848" y2="45238"/>
                        <a14:foregroundMark x1="79029" y1="67857" x2="79029" y2="67857"/>
                        <a14:foregroundMark x1="69536" y1="81250" x2="69536" y2="81250"/>
                        <a14:foregroundMark x1="46578" y1="68750" x2="46578" y2="68750"/>
                        <a14:foregroundMark x1="37086" y1="83333" x2="37086" y2="83333"/>
                        <a14:foregroundMark x1="27594" y1="86310" x2="27594" y2="86310"/>
                        <a14:foregroundMark x1="10596" y1="47619" x2="10596" y2="47619"/>
                        <a14:foregroundMark x1="11038" y1="54762" x2="11038" y2="54762"/>
                        <a14:foregroundMark x1="23841" y1="78869" x2="23841" y2="78869"/>
                        <a14:foregroundMark x1="31788" y1="84524" x2="31788" y2="84524"/>
                        <a14:foregroundMark x1="41280" y1="85714" x2="41280" y2="85714"/>
                        <a14:foregroundMark x1="48344" y1="82738" x2="48344" y2="82738"/>
                        <a14:foregroundMark x1="54967" y1="81845" x2="54967" y2="81845"/>
                        <a14:foregroundMark x1="59603" y1="81845" x2="59603" y2="81845"/>
                        <a14:foregroundMark x1="64459" y1="81845" x2="64459" y2="81845"/>
                        <a14:foregroundMark x1="64901" y1="81845" x2="64901" y2="81845"/>
                        <a14:foregroundMark x1="71082" y1="84524" x2="71082" y2="84524"/>
                        <a14:foregroundMark x1="71082" y1="85119" x2="72406" y2="85119"/>
                        <a14:foregroundMark x1="73731" y1="85119" x2="73731" y2="85119"/>
                        <a14:foregroundMark x1="75276" y1="84524" x2="75276" y2="84524"/>
                        <a14:foregroundMark x1="77704" y1="84524" x2="77704" y2="84524"/>
                        <a14:foregroundMark x1="78587" y1="84524" x2="78587" y2="84524"/>
                        <a14:foregroundMark x1="80353" y1="81250" x2="80353" y2="81250"/>
                        <a14:foregroundMark x1="80353" y1="78869" x2="80353" y2="78869"/>
                        <a14:foregroundMark x1="80353" y1="75595" x2="80353" y2="75595"/>
                        <a14:foregroundMark x1="80353" y1="72321" x2="80353" y2="72321"/>
                        <a14:foregroundMark x1="81015" y1="68750" x2="81015" y2="66071"/>
                        <a14:foregroundMark x1="81898" y1="59821" x2="81898" y2="59821"/>
                        <a14:foregroundMark x1="82340" y1="56548" x2="82340" y2="56548"/>
                        <a14:foregroundMark x1="82340" y1="52083" x2="82340" y2="49405"/>
                        <a14:foregroundMark x1="82340" y1="47619" x2="82340" y2="47619"/>
                        <a14:foregroundMark x1="82340" y1="43750" x2="81015" y2="42560"/>
                        <a14:foregroundMark x1="77042" y1="39881" x2="77042" y2="39881"/>
                        <a14:foregroundMark x1="75276" y1="39286" x2="75276" y2="39286"/>
                        <a14:foregroundMark x1="72406" y1="36310" x2="70640" y2="35417"/>
                        <a14:foregroundMark x1="64018" y1="33631" x2="64018" y2="33631"/>
                        <a14:foregroundMark x1="64018" y1="33631" x2="64018" y2="33631"/>
                        <a14:foregroundMark x1="59603" y1="33036" x2="59603" y2="33036"/>
                        <a14:foregroundMark x1="59161" y1="33036" x2="57837" y2="33036"/>
                        <a14:foregroundMark x1="53642" y1="31845" x2="53642" y2="31845"/>
                        <a14:foregroundMark x1="50773" y1="31845" x2="50773" y2="31845"/>
                        <a14:foregroundMark x1="48786" y1="31845" x2="47020" y2="31250"/>
                        <a14:foregroundMark x1="45033" y1="31250" x2="45033" y2="31250"/>
                        <a14:foregroundMark x1="45033" y1="31250" x2="45033" y2="31250"/>
                        <a14:foregroundMark x1="44150" y1="28571" x2="44150" y2="28571"/>
                        <a14:foregroundMark x1="44150" y1="27381" x2="44150" y2="25298"/>
                        <a14:foregroundMark x1="43709" y1="23512" x2="43709" y2="23512"/>
                        <a14:foregroundMark x1="42826" y1="22917" x2="42826" y2="22917"/>
                        <a14:foregroundMark x1="40839" y1="22321" x2="37969" y2="20238"/>
                        <a14:foregroundMark x1="32892" y1="17857" x2="32892" y2="17857"/>
                        <a14:foregroundMark x1="29581" y1="17857" x2="28035" y2="17857"/>
                        <a14:foregroundMark x1="13907" y1="19643" x2="13907" y2="19643"/>
                        <a14:foregroundMark x1="13024" y1="19643" x2="13024" y2="19643"/>
                        <a14:foregroundMark x1="11700" y1="20238" x2="11700" y2="20238"/>
                        <a14:foregroundMark x1="8389" y1="20238" x2="8389" y2="20238"/>
                        <a14:foregroundMark x1="18764" y1="25893" x2="20088" y2="26786"/>
                        <a14:foregroundMark x1="23841" y1="27976" x2="23841" y2="27976"/>
                        <a14:foregroundMark x1="24724" y1="27976" x2="27152" y2="27976"/>
                        <a14:foregroundMark x1="30464" y1="27976" x2="32450" y2="27976"/>
                        <a14:foregroundMark x1="33775" y1="29167" x2="35099" y2="32440"/>
                        <a14:foregroundMark x1="35099" y1="34226" x2="35099" y2="34226"/>
                        <a14:foregroundMark x1="35099" y1="37500" x2="36203" y2="39286"/>
                        <a14:foregroundMark x1="37969" y1="40774" x2="37969" y2="40774"/>
                        <a14:foregroundMark x1="37969" y1="43155" x2="30905" y2="44345"/>
                        <a14:foregroundMark x1="22958" y1="43750" x2="22958" y2="43750"/>
                        <a14:foregroundMark x1="17219" y1="41369" x2="17219" y2="41369"/>
                        <a14:foregroundMark x1="16336" y1="41369" x2="16336" y2="41369"/>
                        <a14:foregroundMark x1="17660" y1="38690" x2="20088" y2="37500"/>
                        <a14:foregroundMark x1="22517" y1="35417" x2="24283" y2="35417"/>
                        <a14:foregroundMark x1="27594" y1="36310" x2="30905" y2="38095"/>
                        <a14:foregroundMark x1="35099" y1="38690" x2="37528" y2="39286"/>
                        <a14:foregroundMark x1="62472" y1="48214" x2="64018" y2="48214"/>
                        <a14:foregroundMark x1="64459" y1="48214" x2="71082" y2="48214"/>
                        <a14:foregroundMark x1="75276" y1="47619" x2="76600" y2="48810"/>
                        <a14:foregroundMark x1="77042" y1="53274" x2="77704" y2="58333"/>
                        <a14:foregroundMark x1="77704" y1="62202" x2="76159" y2="64881"/>
                        <a14:foregroundMark x1="74834" y1="67262" x2="72406" y2="69940"/>
                        <a14:foregroundMark x1="69536" y1="70536" x2="66667" y2="71131"/>
                        <a14:foregroundMark x1="58720" y1="69345" x2="58720" y2="69345"/>
                        <a14:foregroundMark x1="55408" y1="66667" x2="54084" y2="66667"/>
                        <a14:foregroundMark x1="51656" y1="67857" x2="51656" y2="67857"/>
                        <a14:foregroundMark x1="50773" y1="70536" x2="50773" y2="70536"/>
                        <a14:foregroundMark x1="52097" y1="58929" x2="52097" y2="51488"/>
                        <a14:foregroundMark x1="50773" y1="46429" x2="50773" y2="46429"/>
                        <a14:foregroundMark x1="47903" y1="42560" x2="47903" y2="42560"/>
                        <a14:foregroundMark x1="47020" y1="39286" x2="47020" y2="39286"/>
                        <a14:foregroundMark x1="47461" y1="36310" x2="54525" y2="34821"/>
                        <a14:foregroundMark x1="59161" y1="35417" x2="62031" y2="37500"/>
                        <a14:foregroundMark x1="68653" y1="40774" x2="70640" y2="41964"/>
                        <a14:foregroundMark x1="71965" y1="43750" x2="72406" y2="47024"/>
                        <a14:foregroundMark x1="72406" y1="55357" x2="73289" y2="59821"/>
                        <a14:foregroundMark x1="73731" y1="62798" x2="73731" y2="67262"/>
                        <a14:foregroundMark x1="71523" y1="69940" x2="69095" y2="71726"/>
                        <a14:foregroundMark x1="66667" y1="71726" x2="64901" y2="71726"/>
                        <a14:foregroundMark x1="58278" y1="69940" x2="56954" y2="69940"/>
                        <a14:foregroundMark x1="54525" y1="69940" x2="52097" y2="71131"/>
                        <a14:foregroundMark x1="48344" y1="71726" x2="48344" y2="71726"/>
                        <a14:foregroundMark x1="45475" y1="72917" x2="44150" y2="74405"/>
                        <a14:foregroundMark x1="42826" y1="74405" x2="42826" y2="74405"/>
                        <a14:foregroundMark x1="38852" y1="75000" x2="38852" y2="75000"/>
                        <a14:foregroundMark x1="37969" y1="75000" x2="36645" y2="76190"/>
                        <a14:foregroundMark x1="33775" y1="76190" x2="33775" y2="76190"/>
                        <a14:foregroundMark x1="30905" y1="76786" x2="29581" y2="77381"/>
                        <a14:foregroundMark x1="27152" y1="77381" x2="27152" y2="77381"/>
                        <a14:foregroundMark x1="26711" y1="77381" x2="25166" y2="77381"/>
                        <a14:foregroundMark x1="79470" y1="69345" x2="79470" y2="69345"/>
                        <a14:foregroundMark x1="62914" y1="58333" x2="62914" y2="58333"/>
                        <a14:foregroundMark x1="62914" y1="58333" x2="62914" y2="58333"/>
                        <a14:foregroundMark x1="58278" y1="39881" x2="58278" y2="39881"/>
                        <a14:foregroundMark x1="47461" y1="62798" x2="47461" y2="62798"/>
                        <a14:foregroundMark x1="47461" y1="65476" x2="47461" y2="65476"/>
                        <a14:foregroundMark x1="47903" y1="67262" x2="51656" y2="68750"/>
                        <a14:foregroundMark x1="79470" y1="39881" x2="79470" y2="39881"/>
                        <a14:foregroundMark x1="82781" y1="42560" x2="85210" y2="45833"/>
                        <a14:foregroundMark x1="86534" y1="47619" x2="86534" y2="47619"/>
                        <a14:foregroundMark x1="86976" y1="48214" x2="88962" y2="48810"/>
                        <a14:foregroundMark x1="92715" y1="49405" x2="92715" y2="49405"/>
                        <a14:foregroundMark x1="93157" y1="50298" x2="93157" y2="50298"/>
                        <a14:foregroundMark x1="93598" y1="52679" x2="93598" y2="52679"/>
                        <a14:foregroundMark x1="93157" y1="53869" x2="93157" y2="53869"/>
                        <a14:foregroundMark x1="91832" y1="54762" x2="91832" y2="54762"/>
                        <a14:foregroundMark x1="91170" y1="54762" x2="91170" y2="54762"/>
                        <a14:foregroundMark x1="91170" y1="54762" x2="91170" y2="54762"/>
                        <a14:foregroundMark x1="84106" y1="45833" x2="84106" y2="45833"/>
                        <a14:foregroundMark x1="79912" y1="42560" x2="79912" y2="42560"/>
                        <a14:foregroundMark x1="78146" y1="37500" x2="78146" y2="37500"/>
                        <a14:foregroundMark x1="76600" y1="36310" x2="76159" y2="34226"/>
                        <a14:foregroundMark x1="75276" y1="32440" x2="75276" y2="32440"/>
                        <a14:foregroundMark x1="75276" y1="32440" x2="75276" y2="32440"/>
                        <a14:foregroundMark x1="73289" y1="32440" x2="73289" y2="32440"/>
                        <a14:foregroundMark x1="79470" y1="34821" x2="79470" y2="34821"/>
                        <a14:foregroundMark x1="81457" y1="37500" x2="82781" y2="39286"/>
                        <a14:foregroundMark x1="83223" y1="39881" x2="83223" y2="39881"/>
                        <a14:foregroundMark x1="84106" y1="39881" x2="84106" y2="39881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8637" y="5157193"/>
            <a:ext cx="1725365" cy="1279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84592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4E771BC-D3A1-48BC-9879-9E47AB4F7FB1}" type="datetime1">
              <a:rPr lang="zh-TW" altLang="en-US" sz="901" smtClean="0">
                <a:solidFill>
                  <a:srgbClr val="009DD9"/>
                </a:solidFill>
                <a:latin typeface="Times New Roman"/>
                <a:ea typeface="標楷體"/>
              </a:rPr>
              <a:pPr>
                <a:defRPr/>
              </a:pPr>
              <a:t>19/8/13</a:t>
            </a:fld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066A31-7E54-4457-B739-5849F72B97A7}" type="slidenum">
              <a:rPr lang="zh-TW" altLang="en-US" sz="1500" smtClean="0">
                <a:solidFill>
                  <a:srgbClr val="009DD9"/>
                </a:solidFill>
                <a:latin typeface="標楷體" panose="03000509000000000000" pitchFamily="65" charset="-120"/>
                <a:ea typeface="標楷體" panose="03000509000000000000" pitchFamily="65" charset="-120"/>
              </a:rPr>
              <a:pPr>
                <a:defRPr/>
              </a:pPr>
              <a:t>‹#›</a:t>
            </a:fld>
            <a:endParaRPr lang="zh-TW" altLang="en-US" sz="1500">
              <a:solidFill>
                <a:srgbClr val="009DD9"/>
              </a:solidFill>
              <a:latin typeface="標楷體" panose="03000509000000000000" pitchFamily="65" charset="-120"/>
              <a:ea typeface="標楷體" panose="03000509000000000000" pitchFamily="65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1032778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1FC030B-7B54-4143-B582-9B669A389C48}" type="datetime1">
              <a:rPr lang="zh-TW" altLang="en-US" sz="901" smtClean="0">
                <a:solidFill>
                  <a:srgbClr val="0F6FC6">
                    <a:lumMod val="75000"/>
                    <a:lumOff val="25000"/>
                  </a:srgbClr>
                </a:solidFill>
                <a:latin typeface="Times New Roman"/>
                <a:ea typeface="標楷體"/>
              </a:rPr>
              <a:pPr>
                <a:defRPr/>
              </a:pPr>
              <a:t>19/8/13</a:t>
            </a:fld>
            <a:endParaRPr lang="zh-TW" altLang="en-US" sz="901">
              <a:solidFill>
                <a:srgbClr val="0F6FC6">
                  <a:lumMod val="75000"/>
                  <a:lumOff val="25000"/>
                </a:srgbClr>
              </a:solidFill>
              <a:latin typeface="Times New Roman"/>
              <a:ea typeface="標楷體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066A31-7E54-4457-B739-5849F72B97A7}" type="slidenum">
              <a:rPr lang="zh-TW" altLang="en-US" sz="1500" smtClean="0">
                <a:solidFill>
                  <a:srgbClr val="0F6FC6">
                    <a:lumMod val="75000"/>
                    <a:lumOff val="25000"/>
                  </a:srgbClr>
                </a:solidFill>
                <a:latin typeface="標楷體" panose="03000509000000000000" pitchFamily="65" charset="-120"/>
                <a:ea typeface="標楷體" panose="03000509000000000000" pitchFamily="65" charset="-120"/>
              </a:rPr>
              <a:pPr>
                <a:defRPr/>
              </a:pPr>
              <a:t>‹#›</a:t>
            </a:fld>
            <a:endParaRPr lang="zh-TW" altLang="en-US" sz="1500">
              <a:solidFill>
                <a:srgbClr val="0F6FC6">
                  <a:lumMod val="75000"/>
                  <a:lumOff val="25000"/>
                </a:srgbClr>
              </a:solidFill>
              <a:latin typeface="標楷體" panose="03000509000000000000" pitchFamily="65" charset="-120"/>
              <a:ea typeface="標楷體" panose="03000509000000000000" pitchFamily="65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2128828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5F4DFA89-BA43-4EDF-8B3B-171A4A2C7EE1}" type="datetime1">
              <a:rPr lang="zh-TW" altLang="en-US" sz="901" smtClean="0">
                <a:solidFill>
                  <a:srgbClr val="009DD9"/>
                </a:solidFill>
                <a:latin typeface="Times New Roman"/>
                <a:ea typeface="標楷體"/>
              </a:rPr>
              <a:pPr>
                <a:defRPr/>
              </a:pPr>
              <a:t>19/8/13</a:t>
            </a:fld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066A31-7E54-4457-B739-5849F72B97A7}" type="slidenum">
              <a:rPr lang="zh-TW" altLang="en-US" sz="1500" smtClean="0">
                <a:solidFill>
                  <a:prstClr val="black"/>
                </a:solidFill>
                <a:latin typeface="Times New Roman"/>
                <a:ea typeface="標楷體"/>
              </a:rPr>
              <a:pPr>
                <a:defRPr/>
              </a:pPr>
              <a:t>‹#›</a:t>
            </a:fld>
            <a:endParaRPr lang="zh-TW" altLang="en-US" sz="1500">
              <a:solidFill>
                <a:prstClr val="black"/>
              </a:solidFill>
              <a:latin typeface="Times New Roman"/>
              <a:ea typeface="標楷體"/>
            </a:endParaRPr>
          </a:p>
        </p:txBody>
      </p:sp>
    </p:spTree>
    <p:extLst>
      <p:ext uri="{BB962C8B-B14F-4D97-AF65-F5344CB8AC3E}">
        <p14:creationId xmlns:p14="http://schemas.microsoft.com/office/powerpoint/2010/main" val="1523674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F8C03D0-B1CD-4FD1-B0A6-2ABC7C76AEB1}" type="datetime1">
              <a:rPr lang="zh-TW" altLang="en-US" sz="901" smtClean="0">
                <a:solidFill>
                  <a:srgbClr val="0F6FC6">
                    <a:lumMod val="75000"/>
                    <a:lumOff val="25000"/>
                  </a:srgbClr>
                </a:solidFill>
                <a:latin typeface="Times New Roman"/>
                <a:ea typeface="標楷體"/>
              </a:rPr>
              <a:pPr>
                <a:defRPr/>
              </a:pPr>
              <a:t>19/8/13</a:t>
            </a:fld>
            <a:endParaRPr lang="zh-TW" altLang="en-US" sz="901">
              <a:solidFill>
                <a:srgbClr val="0F6FC6">
                  <a:lumMod val="75000"/>
                  <a:lumOff val="25000"/>
                </a:srgbClr>
              </a:solidFill>
              <a:latin typeface="Times New Roman"/>
              <a:ea typeface="標楷體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TW" altLang="en-US" sz="901">
              <a:solidFill>
                <a:srgbClr val="0F6FC6">
                  <a:lumMod val="75000"/>
                  <a:lumOff val="25000"/>
                </a:srgbClr>
              </a:solidFill>
              <a:latin typeface="Times New Roman"/>
              <a:ea typeface="標楷體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066A31-7E54-4457-B739-5849F72B97A7}" type="slidenum">
              <a:rPr lang="zh-TW" altLang="en-US" sz="1500" smtClean="0">
                <a:solidFill>
                  <a:srgbClr val="0F6FC6">
                    <a:lumMod val="75000"/>
                    <a:lumOff val="25000"/>
                  </a:srgbClr>
                </a:solidFill>
                <a:latin typeface="標楷體" panose="03000509000000000000" pitchFamily="65" charset="-120"/>
                <a:ea typeface="標楷體" panose="03000509000000000000" pitchFamily="65" charset="-120"/>
              </a:rPr>
              <a:pPr>
                <a:defRPr/>
              </a:pPr>
              <a:t>‹#›</a:t>
            </a:fld>
            <a:endParaRPr lang="zh-TW" altLang="en-US" sz="1500">
              <a:solidFill>
                <a:srgbClr val="0F6FC6">
                  <a:lumMod val="75000"/>
                  <a:lumOff val="25000"/>
                </a:srgbClr>
              </a:solidFill>
              <a:latin typeface="標楷體" panose="03000509000000000000" pitchFamily="65" charset="-120"/>
              <a:ea typeface="標楷體" panose="03000509000000000000" pitchFamily="65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2234284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E649B607-3E02-4398-8E9E-5ED174410282}" type="datetime1">
              <a:rPr lang="zh-TW" altLang="en-US" sz="901" smtClean="0">
                <a:solidFill>
                  <a:srgbClr val="009DD9"/>
                </a:solidFill>
                <a:latin typeface="Times New Roman"/>
                <a:ea typeface="標楷體"/>
              </a:rPr>
              <a:pPr>
                <a:defRPr/>
              </a:pPr>
              <a:t>19/8/13</a:t>
            </a:fld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066A31-7E54-4457-B739-5849F72B97A7}" type="slidenum">
              <a:rPr lang="zh-TW" altLang="en-US" sz="1500" smtClean="0">
                <a:solidFill>
                  <a:srgbClr val="009DD9"/>
                </a:solidFill>
                <a:latin typeface="標楷體" panose="03000509000000000000" pitchFamily="65" charset="-120"/>
                <a:ea typeface="標楷體" panose="03000509000000000000" pitchFamily="65" charset="-120"/>
              </a:rPr>
              <a:pPr>
                <a:defRPr/>
              </a:pPr>
              <a:t>‹#›</a:t>
            </a:fld>
            <a:endParaRPr lang="zh-TW" altLang="en-US" sz="1500">
              <a:solidFill>
                <a:srgbClr val="009DD9"/>
              </a:solidFill>
              <a:latin typeface="標楷體" panose="03000509000000000000" pitchFamily="65" charset="-120"/>
              <a:ea typeface="標楷體" panose="03000509000000000000" pitchFamily="65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1300731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6618C39-3D77-4C74-8B1E-282B63561BC3}" type="datetime1">
              <a:rPr lang="zh-TW" altLang="en-US" sz="901" smtClean="0">
                <a:solidFill>
                  <a:srgbClr val="009DD9"/>
                </a:solidFill>
                <a:latin typeface="Times New Roman"/>
                <a:ea typeface="標楷體"/>
              </a:rPr>
              <a:pPr>
                <a:defRPr/>
              </a:pPr>
              <a:t>19/8/13</a:t>
            </a:fld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066A31-7E54-4457-B739-5849F72B97A7}" type="slidenum">
              <a:rPr lang="zh-TW" altLang="en-US" sz="1500" smtClean="0">
                <a:solidFill>
                  <a:srgbClr val="009DD9"/>
                </a:solidFill>
                <a:latin typeface="標楷體" panose="03000509000000000000" pitchFamily="65" charset="-120"/>
                <a:ea typeface="標楷體" panose="03000509000000000000" pitchFamily="65" charset="-120"/>
              </a:rPr>
              <a:pPr>
                <a:defRPr/>
              </a:pPr>
              <a:t>‹#›</a:t>
            </a:fld>
            <a:endParaRPr lang="zh-TW" altLang="en-US" sz="1500">
              <a:solidFill>
                <a:srgbClr val="009DD9"/>
              </a:solidFill>
              <a:latin typeface="標楷體" panose="03000509000000000000" pitchFamily="65" charset="-120"/>
              <a:ea typeface="標楷體" panose="03000509000000000000" pitchFamily="65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147141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894AE6B-8EF2-4705-817B-684AC5BA1F46}" type="datetime1">
              <a:rPr lang="zh-TW" altLang="en-US" sz="901" smtClean="0">
                <a:solidFill>
                  <a:srgbClr val="009DD9"/>
                </a:solidFill>
                <a:latin typeface="Times New Roman"/>
                <a:ea typeface="標楷體"/>
              </a:rPr>
              <a:pPr>
                <a:defRPr/>
              </a:pPr>
              <a:t>19/8/13</a:t>
            </a:fld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066A31-7E54-4457-B739-5849F72B97A7}" type="slidenum">
              <a:rPr lang="zh-TW" altLang="en-US" sz="1500" smtClean="0">
                <a:solidFill>
                  <a:srgbClr val="009DD9"/>
                </a:solidFill>
                <a:latin typeface="標楷體" panose="03000509000000000000" pitchFamily="65" charset="-120"/>
                <a:ea typeface="標楷體" panose="03000509000000000000" pitchFamily="65" charset="-120"/>
              </a:rPr>
              <a:pPr>
                <a:defRPr/>
              </a:pPr>
              <a:t>‹#›</a:t>
            </a:fld>
            <a:endParaRPr lang="zh-TW" altLang="en-US" sz="1500">
              <a:solidFill>
                <a:srgbClr val="009DD9"/>
              </a:solidFill>
              <a:latin typeface="標楷體" panose="03000509000000000000" pitchFamily="65" charset="-120"/>
              <a:ea typeface="標楷體" panose="03000509000000000000" pitchFamily="65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3388793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F2BD480-8C47-4F24-9FEF-5D1022940FB4}" type="datetime1">
              <a:rPr lang="zh-TW" altLang="en-US" sz="901" smtClean="0">
                <a:solidFill>
                  <a:srgbClr val="009DD9"/>
                </a:solidFill>
                <a:latin typeface="Times New Roman"/>
                <a:ea typeface="標楷體"/>
              </a:rPr>
              <a:pPr>
                <a:defRPr/>
              </a:pPr>
              <a:t>19/8/13</a:t>
            </a:fld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066A31-7E54-4457-B739-5849F72B97A7}" type="slidenum">
              <a:rPr lang="zh-TW" altLang="en-US" sz="1800" smtClean="0">
                <a:solidFill>
                  <a:prstClr val="black"/>
                </a:solidFill>
                <a:latin typeface="Times New Roman" panose="02020603050405020304" pitchFamily="18" charset="0"/>
                <a:ea typeface="標楷體" panose="03000509000000000000" pitchFamily="65" charset="-120"/>
                <a:cs typeface="Times New Roman" panose="02020603050405020304" pitchFamily="18" charset="0"/>
              </a:rPr>
              <a:pPr>
                <a:defRPr/>
              </a:pPr>
              <a:t>‹#›</a:t>
            </a:fld>
            <a:endParaRPr lang="zh-TW" altLang="en-US" sz="1800" dirty="0">
              <a:solidFill>
                <a:prstClr val="black"/>
              </a:solidFill>
              <a:latin typeface="Times New Roman" panose="02020603050405020304" pitchFamily="18" charset="0"/>
              <a:ea typeface="標楷體" panose="03000509000000000000" pitchFamily="65" charset="-12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4193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F5B23BB-CDC3-4F62-8F17-3D6681D40C8E}" type="datetime1">
              <a:rPr lang="zh-TW" altLang="en-US" sz="901" smtClean="0">
                <a:solidFill>
                  <a:srgbClr val="0F6FC6">
                    <a:lumMod val="75000"/>
                    <a:lumOff val="25000"/>
                  </a:srgbClr>
                </a:solidFill>
                <a:latin typeface="Times New Roman"/>
                <a:ea typeface="標楷體"/>
              </a:rPr>
              <a:pPr>
                <a:defRPr/>
              </a:pPr>
              <a:t>19/8/13</a:t>
            </a:fld>
            <a:endParaRPr lang="zh-TW" altLang="en-US" sz="901">
              <a:solidFill>
                <a:srgbClr val="0F6FC6">
                  <a:lumMod val="75000"/>
                  <a:lumOff val="25000"/>
                </a:srgbClr>
              </a:solidFill>
              <a:latin typeface="Times New Roman"/>
              <a:ea typeface="標楷體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TW" altLang="en-US" sz="901">
              <a:solidFill>
                <a:srgbClr val="0F6FC6">
                  <a:lumMod val="75000"/>
                  <a:lumOff val="25000"/>
                </a:srgbClr>
              </a:solidFill>
              <a:latin typeface="Times New Roman"/>
              <a:ea typeface="標楷體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066A31-7E54-4457-B739-5849F72B97A7}" type="slidenum">
              <a:rPr lang="zh-TW" altLang="en-US" sz="1500" smtClean="0">
                <a:solidFill>
                  <a:srgbClr val="0F6FC6">
                    <a:lumMod val="75000"/>
                    <a:lumOff val="25000"/>
                  </a:srgbClr>
                </a:solidFill>
                <a:latin typeface="標楷體" panose="03000509000000000000" pitchFamily="65" charset="-120"/>
                <a:ea typeface="標楷體" panose="03000509000000000000" pitchFamily="65" charset="-120"/>
              </a:rPr>
              <a:pPr>
                <a:defRPr/>
              </a:pPr>
              <a:t>‹#›</a:t>
            </a:fld>
            <a:endParaRPr lang="zh-TW" altLang="en-US" sz="1500">
              <a:solidFill>
                <a:srgbClr val="0F6FC6">
                  <a:lumMod val="75000"/>
                  <a:lumOff val="25000"/>
                </a:srgbClr>
              </a:solidFill>
              <a:latin typeface="標楷體" panose="03000509000000000000" pitchFamily="65" charset="-120"/>
              <a:ea typeface="標楷體" panose="03000509000000000000" pitchFamily="65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3169462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EDC6FE8-6D9A-4ADC-990D-DBF786A83DC4}" type="datetime1">
              <a:rPr lang="zh-TW" altLang="en-US" sz="901" smtClean="0">
                <a:solidFill>
                  <a:srgbClr val="009DD9"/>
                </a:solidFill>
                <a:latin typeface="Times New Roman"/>
                <a:ea typeface="標楷體"/>
              </a:rPr>
              <a:pPr>
                <a:defRPr/>
              </a:pPr>
              <a:t>19/8/13</a:t>
            </a:fld>
            <a:endParaRPr lang="zh-TW" altLang="en-US" sz="901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sz="901" dirty="0">
              <a:solidFill>
                <a:srgbClr val="009DD9"/>
              </a:solidFill>
              <a:latin typeface="Times New Roman"/>
              <a:ea typeface="標楷體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066A31-7E54-4457-B739-5849F72B97A7}" type="slidenum">
              <a:rPr lang="zh-TW" altLang="en-US" sz="1500" smtClean="0">
                <a:solidFill>
                  <a:srgbClr val="009DD9"/>
                </a:solidFill>
                <a:latin typeface="標楷體" panose="03000509000000000000" pitchFamily="65" charset="-120"/>
                <a:ea typeface="標楷體" panose="03000509000000000000" pitchFamily="65" charset="-120"/>
              </a:rPr>
              <a:pPr>
                <a:defRPr/>
              </a:pPr>
              <a:t>‹#›</a:t>
            </a:fld>
            <a:endParaRPr lang="zh-TW" altLang="en-US" sz="1500">
              <a:solidFill>
                <a:srgbClr val="009DD9"/>
              </a:solidFill>
              <a:latin typeface="標楷體" panose="03000509000000000000" pitchFamily="65" charset="-120"/>
              <a:ea typeface="標楷體" panose="03000509000000000000" pitchFamily="65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154553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87E8DEF-8606-483C-8853-322690DC6284}" type="datetime1">
              <a:rPr lang="zh-TW" altLang="en-US" smtClean="0">
                <a:solidFill>
                  <a:srgbClr val="009DD9"/>
                </a:solidFill>
              </a:rPr>
              <a:pPr>
                <a:defRPr/>
              </a:pPr>
              <a:t>19/8/13</a:t>
            </a:fld>
            <a:endParaRPr lang="zh-TW" altLang="en-US">
              <a:solidFill>
                <a:srgbClr val="009DD9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zh-TW" altLang="en-US">
              <a:solidFill>
                <a:srgbClr val="009DD9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75066A31-7E54-4457-B739-5849F72B97A7}" type="slidenum">
              <a:rPr lang="zh-TW" altLang="en-US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49023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microsoft.com/office/2007/relationships/hdphoto" Target="../media/hdphoto2.wdp"/><Relationship Id="rId5" Type="http://schemas.openxmlformats.org/officeDocument/2006/relationships/image" Target="../media/image3.jpeg"/><Relationship Id="rId6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群組 3"/>
          <p:cNvGrpSpPr/>
          <p:nvPr/>
        </p:nvGrpSpPr>
        <p:grpSpPr>
          <a:xfrm>
            <a:off x="984952" y="1548281"/>
            <a:ext cx="3487300" cy="2532312"/>
            <a:chOff x="1284932" y="1308032"/>
            <a:chExt cx="4649734" cy="3376416"/>
          </a:xfrm>
        </p:grpSpPr>
        <p:grpSp>
          <p:nvGrpSpPr>
            <p:cNvPr id="7" name="群組 6"/>
            <p:cNvGrpSpPr/>
            <p:nvPr/>
          </p:nvGrpSpPr>
          <p:grpSpPr>
            <a:xfrm>
              <a:off x="3975248" y="1431343"/>
              <a:ext cx="1959418" cy="3252651"/>
              <a:chOff x="2756272" y="1489167"/>
              <a:chExt cx="1959418" cy="3252651"/>
            </a:xfrm>
          </p:grpSpPr>
          <p:pic>
            <p:nvPicPr>
              <p:cNvPr id="3" name="圖片 2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714" t="53873" r="30858" b="12349"/>
              <a:stretch/>
            </p:blipFill>
            <p:spPr>
              <a:xfrm rot="5400000">
                <a:off x="2220684" y="2246813"/>
                <a:ext cx="3252651" cy="1737360"/>
              </a:xfrm>
              <a:prstGeom prst="rect">
                <a:avLst/>
              </a:prstGeom>
            </p:spPr>
          </p:pic>
          <p:cxnSp>
            <p:nvCxnSpPr>
              <p:cNvPr id="5" name="直線單箭頭接點 4"/>
              <p:cNvCxnSpPr/>
              <p:nvPr/>
            </p:nvCxnSpPr>
            <p:spPr>
              <a:xfrm>
                <a:off x="2756272" y="3135086"/>
                <a:ext cx="396000" cy="0"/>
              </a:xfrm>
              <a:prstGeom prst="straightConnector1">
                <a:avLst/>
              </a:prstGeom>
              <a:ln w="381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圓角矩形 5"/>
              <p:cNvSpPr/>
              <p:nvPr/>
            </p:nvSpPr>
            <p:spPr>
              <a:xfrm>
                <a:off x="3252652" y="2926080"/>
                <a:ext cx="1188720" cy="404949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8581" tIns="34289" rIns="68581" bIns="34289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TW" altLang="en-US" sz="1200" b="1"/>
              </a:p>
            </p:txBody>
          </p:sp>
        </p:grpSp>
        <p:pic>
          <p:nvPicPr>
            <p:cNvPr id="9" name="圖片 8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99" t="24000" r="38571" b="32000"/>
            <a:stretch/>
          </p:blipFill>
          <p:spPr>
            <a:xfrm>
              <a:off x="1880636" y="1431343"/>
              <a:ext cx="1520932" cy="3253105"/>
            </a:xfrm>
            <a:prstGeom prst="rect">
              <a:avLst/>
            </a:prstGeom>
          </p:spPr>
        </p:pic>
        <p:sp>
          <p:nvSpPr>
            <p:cNvPr id="10" name="文字方塊 9"/>
            <p:cNvSpPr txBox="1"/>
            <p:nvPr/>
          </p:nvSpPr>
          <p:spPr>
            <a:xfrm>
              <a:off x="1284932" y="1308032"/>
              <a:ext cx="5304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/>
                <a:t>(A)</a:t>
              </a:r>
              <a:endParaRPr lang="zh-TW" altLang="en-US" sz="1200" b="1" dirty="0"/>
            </a:p>
          </p:txBody>
        </p:sp>
        <p:sp>
          <p:nvSpPr>
            <p:cNvPr id="11" name="文字方塊 10"/>
            <p:cNvSpPr txBox="1"/>
            <p:nvPr/>
          </p:nvSpPr>
          <p:spPr>
            <a:xfrm>
              <a:off x="3531150" y="1308032"/>
              <a:ext cx="8400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/>
                <a:t>(B)</a:t>
              </a:r>
              <a:endParaRPr lang="zh-TW" altLang="en-US" sz="1200" b="1" dirty="0"/>
            </a:p>
          </p:txBody>
        </p:sp>
      </p:grpSp>
      <p:sp>
        <p:nvSpPr>
          <p:cNvPr id="12" name="文字方塊 11"/>
          <p:cNvSpPr txBox="1"/>
          <p:nvPr/>
        </p:nvSpPr>
        <p:spPr>
          <a:xfrm flipH="1">
            <a:off x="823851" y="4389738"/>
            <a:ext cx="7131428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400" b="1" dirty="0" smtClean="0"/>
              <a:t>Supplementary Figure S1.</a:t>
            </a:r>
            <a:r>
              <a:rPr lang="en-US" altLang="zh-TW" sz="1400" dirty="0"/>
              <a:t> </a:t>
            </a:r>
            <a:r>
              <a:rPr lang="en-US" altLang="zh-TW" sz="1400" dirty="0"/>
              <a:t>BEFV virus particle </a:t>
            </a:r>
            <a:r>
              <a:rPr lang="en-US" altLang="zh-TW" sz="1400" dirty="0" smtClean="0"/>
              <a:t>purification using sucrose </a:t>
            </a:r>
            <a:r>
              <a:rPr lang="en-US" altLang="zh-TW" sz="1400" dirty="0" smtClean="0"/>
              <a:t>gradient centrifugation. </a:t>
            </a:r>
            <a:r>
              <a:rPr lang="en-US" altLang="zh-TW" sz="1400" dirty="0"/>
              <a:t>(A) </a:t>
            </a:r>
            <a:r>
              <a:rPr lang="en-US" altLang="zh-TW" sz="1400" dirty="0" smtClean="0"/>
              <a:t>Sucrose </a:t>
            </a:r>
            <a:r>
              <a:rPr lang="en-US" altLang="zh-TW" sz="1400" dirty="0"/>
              <a:t>gradient </a:t>
            </a:r>
            <a:r>
              <a:rPr lang="en-US" altLang="zh-TW" sz="1400" dirty="0" smtClean="0"/>
              <a:t>layers (30%, 40%, 50%) </a:t>
            </a:r>
            <a:r>
              <a:rPr lang="en-US" altLang="zh-TW" sz="1400" dirty="0"/>
              <a:t>were </a:t>
            </a:r>
            <a:r>
              <a:rPr lang="en-US" altLang="zh-TW" sz="1400" dirty="0" smtClean="0"/>
              <a:t>constructed and </a:t>
            </a:r>
            <a:r>
              <a:rPr lang="en-US" altLang="zh-TW" sz="1400" dirty="0" smtClean="0"/>
              <a:t>concentrated virus supernatant </a:t>
            </a:r>
            <a:r>
              <a:rPr lang="en-US" altLang="zh-TW" sz="1400" dirty="0" smtClean="0"/>
              <a:t>was layered on </a:t>
            </a:r>
            <a:r>
              <a:rPr lang="en-US" altLang="zh-TW" sz="1400" dirty="0"/>
              <a:t>top. (B) After </a:t>
            </a:r>
            <a:r>
              <a:rPr lang="en-US" altLang="zh-TW" sz="1400" dirty="0" smtClean="0"/>
              <a:t>centrifugation </a:t>
            </a:r>
            <a:r>
              <a:rPr lang="en-US" altLang="zh-TW" sz="1400" dirty="0" smtClean="0"/>
              <a:t>(40,000 </a:t>
            </a:r>
            <a:r>
              <a:rPr lang="en-US" altLang="zh-TW" sz="1400" dirty="0"/>
              <a:t>rpm, 4°C, for 4 </a:t>
            </a:r>
            <a:r>
              <a:rPr lang="en-US" altLang="zh-TW" sz="1400" dirty="0" smtClean="0"/>
              <a:t>hours), </a:t>
            </a:r>
            <a:r>
              <a:rPr lang="en-US" altLang="zh-TW" sz="1400" dirty="0"/>
              <a:t>a clear band of concentrated virus was isolated (red box</a:t>
            </a:r>
            <a:r>
              <a:rPr lang="en-US" altLang="zh-TW" sz="1400" dirty="0" smtClean="0"/>
              <a:t>). (C) Protein samples were analyzed by Western blotting with goat anti-whole BEFV antiserum. Sample 1</a:t>
            </a:r>
            <a:r>
              <a:rPr lang="en-US" altLang="zh-TW" sz="1400" dirty="0" smtClean="0"/>
              <a:t>: </a:t>
            </a:r>
            <a:r>
              <a:rPr lang="en-US" altLang="zh-TW" sz="1400" dirty="0" smtClean="0"/>
              <a:t>unpurified virus culture supernatant; Sample 2: concentrated </a:t>
            </a:r>
            <a:r>
              <a:rPr lang="en-US" altLang="zh-TW" sz="1400" dirty="0" smtClean="0"/>
              <a:t>virus particles; </a:t>
            </a:r>
            <a:r>
              <a:rPr lang="en-US" altLang="zh-TW" sz="1400" dirty="0" smtClean="0"/>
              <a:t>Sample 3: the virus sample after sucrose gradient </a:t>
            </a:r>
            <a:r>
              <a:rPr lang="en-US" altLang="zh-TW" sz="1400" dirty="0" smtClean="0"/>
              <a:t>purification; </a:t>
            </a:r>
            <a:r>
              <a:rPr lang="en-US" altLang="zh-TW" sz="1400" dirty="0" smtClean="0"/>
              <a:t>Sample 4: </a:t>
            </a:r>
            <a:r>
              <a:rPr lang="en-US" altLang="zh-TW" sz="1400" dirty="0" smtClean="0"/>
              <a:t>BHK</a:t>
            </a:r>
            <a:r>
              <a:rPr lang="en-US" altLang="zh-TW" sz="1400" dirty="0" smtClean="0"/>
              <a:t>-21 cell culture supernatant.</a:t>
            </a:r>
            <a:endParaRPr lang="zh-TW" altLang="en-US" sz="1400" b="1" dirty="0"/>
          </a:p>
        </p:txBody>
      </p:sp>
      <p:sp>
        <p:nvSpPr>
          <p:cNvPr id="2" name="文字方塊 1"/>
          <p:cNvSpPr txBox="1"/>
          <p:nvPr/>
        </p:nvSpPr>
        <p:spPr>
          <a:xfrm>
            <a:off x="2159726" y="4798423"/>
            <a:ext cx="184731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TW" altLang="en-US" dirty="0"/>
          </a:p>
        </p:txBody>
      </p:sp>
      <p:pic>
        <p:nvPicPr>
          <p:cNvPr id="13" name="圖片 12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54059" y="1640762"/>
            <a:ext cx="2683171" cy="2439489"/>
          </a:xfrm>
          <a:prstGeom prst="rect">
            <a:avLst/>
          </a:prstGeom>
          <a:noFill/>
        </p:spPr>
      </p:pic>
      <p:sp>
        <p:nvSpPr>
          <p:cNvPr id="14" name="文字方塊 13"/>
          <p:cNvSpPr txBox="1"/>
          <p:nvPr/>
        </p:nvSpPr>
        <p:spPr>
          <a:xfrm>
            <a:off x="4943891" y="1582150"/>
            <a:ext cx="630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 smtClean="0"/>
              <a:t>(C)</a:t>
            </a:r>
            <a:endParaRPr lang="zh-TW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7490006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豆">
      <a:majorFont>
        <a:latin typeface="Times New Roman"/>
        <a:ea typeface="標楷體"/>
        <a:cs typeface=""/>
      </a:majorFont>
      <a:minorFont>
        <a:latin typeface="Times New Roman"/>
        <a:ea typeface="標楷體"/>
        <a:cs typeface="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36</TotalTime>
  <Words>135</Words>
  <Application>Microsoft Macintosh PowerPoint</Application>
  <PresentationFormat>如螢幕大小 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俞靜 曾</dc:creator>
  <cp:lastModifiedBy>Cheng LiTing</cp:lastModifiedBy>
  <cp:revision>147</cp:revision>
  <dcterms:created xsi:type="dcterms:W3CDTF">2019-03-02T05:27:29Z</dcterms:created>
  <dcterms:modified xsi:type="dcterms:W3CDTF">2019-08-13T02:35:08Z</dcterms:modified>
</cp:coreProperties>
</file>